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7" r:id="rId2"/>
    <p:sldId id="28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80208" autoAdjust="0"/>
  </p:normalViewPr>
  <p:slideViewPr>
    <p:cSldViewPr snapToGrid="0">
      <p:cViewPr varScale="1">
        <p:scale>
          <a:sx n="110" d="100"/>
          <a:sy n="110" d="100"/>
        </p:scale>
        <p:origin x="738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ADBBA5-50CA-4263-A788-E9FC01887382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5ECC26-37C7-4834-B399-DFC150B96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4583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2197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9618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5420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674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3124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1351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3364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6275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4336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2745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9530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DD4E9-A312-4570-8827-39C10D5829E4}" type="datetimeFigureOut">
              <a:rPr lang="en-GB" smtClean="0"/>
              <a:t>14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01CD35-580B-4025-8599-2FC06A9BC5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5919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6102" y="2742566"/>
            <a:ext cx="7886700" cy="1325563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</a:pPr>
            <a:r>
              <a:rPr lang="en-GB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aptation to low pH and lignocellulosic inhibitors resulting in ethanolic fermentation and growth of </a:t>
            </a:r>
            <a:r>
              <a:rPr lang="en-GB" sz="1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ccharomyces cerevisiae</a:t>
            </a:r>
            <a:r>
              <a:rPr lang="en-GB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GB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katachalam Narayanan</a:t>
            </a:r>
            <a:r>
              <a:rPr lang="en-GB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Violeta </a:t>
            </a:r>
            <a:r>
              <a:rPr lang="en-GB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ànchez</a:t>
            </a: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Nogué</a:t>
            </a:r>
            <a:r>
              <a:rPr lang="en-GB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d WJ van Niel</a:t>
            </a:r>
            <a:r>
              <a:rPr lang="en-GB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*</a:t>
            </a: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arie F. Gorwa-Grauslund</a:t>
            </a:r>
            <a:r>
              <a:rPr lang="en-GB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vision of Applied Microbiology, Department of Chemistry, Lund University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O. Box 124, SE 221 00 Lund, Sweden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sent address: National Bioenergy Center, National Renewable Energy Laboratory. 15013 Denver West Parkway, Golden, Colorado 80401, USA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mail: 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katachalam.narayanan@tmb.lth.se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oleta.sanchezinogue@nrel.gov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.van_niel@tmb.lth.se (EvN)*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ie-francoise.gorwa-grauslund@tmb.lth.se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Corresponding author</a:t>
            </a:r>
            <a:b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94277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2471" y="357681"/>
            <a:ext cx="358177" cy="235237"/>
          </a:xfrm>
        </p:spPr>
        <p:txBody>
          <a:bodyPr>
            <a:noAutofit/>
          </a:bodyPr>
          <a:lstStyle/>
          <a:p>
            <a:pPr algn="ctr"/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553"/>
          <a:stretch/>
        </p:blipFill>
        <p:spPr>
          <a:xfrm>
            <a:off x="2650837" y="645247"/>
            <a:ext cx="1102157" cy="173432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9889"/>
          <a:stretch/>
        </p:blipFill>
        <p:spPr>
          <a:xfrm>
            <a:off x="4186814" y="645416"/>
            <a:ext cx="1031298" cy="1734157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692"/>
          <a:stretch/>
        </p:blipFill>
        <p:spPr>
          <a:xfrm>
            <a:off x="1062471" y="3283971"/>
            <a:ext cx="1154546" cy="1911927"/>
          </a:xfrm>
          <a:prstGeom prst="rect">
            <a:avLst/>
          </a:prstGeom>
        </p:spPr>
      </p:pic>
      <p:grpSp>
        <p:nvGrpSpPr>
          <p:cNvPr id="41" name="Group 40"/>
          <p:cNvGrpSpPr/>
          <p:nvPr/>
        </p:nvGrpSpPr>
        <p:grpSpPr>
          <a:xfrm>
            <a:off x="1062472" y="645064"/>
            <a:ext cx="4211925" cy="4467707"/>
            <a:chOff x="1062472" y="645064"/>
            <a:chExt cx="4211925" cy="4467707"/>
          </a:xfrm>
        </p:grpSpPr>
        <p:grpSp>
          <p:nvGrpSpPr>
            <p:cNvPr id="34" name="Group 33"/>
            <p:cNvGrpSpPr/>
            <p:nvPr/>
          </p:nvGrpSpPr>
          <p:grpSpPr>
            <a:xfrm>
              <a:off x="1062472" y="645064"/>
              <a:ext cx="4211925" cy="1829151"/>
              <a:chOff x="1062472" y="645064"/>
              <a:chExt cx="4211925" cy="1829151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9865"/>
              <a:stretch/>
            </p:blipFill>
            <p:spPr>
              <a:xfrm>
                <a:off x="1062472" y="645064"/>
                <a:ext cx="1217309" cy="1828800"/>
              </a:xfrm>
              <a:prstGeom prst="rect">
                <a:avLst/>
              </a:prstGeom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0553"/>
              <a:stretch/>
            </p:blipFill>
            <p:spPr>
              <a:xfrm>
                <a:off x="2650838" y="645247"/>
                <a:ext cx="1162195" cy="1828800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9889"/>
              <a:stretch/>
            </p:blipFill>
            <p:spPr>
              <a:xfrm>
                <a:off x="4186815" y="645415"/>
                <a:ext cx="1087582" cy="1828800"/>
              </a:xfrm>
              <a:prstGeom prst="rect">
                <a:avLst/>
              </a:prstGeom>
            </p:spPr>
          </p:pic>
        </p:grpSp>
        <p:grpSp>
          <p:nvGrpSpPr>
            <p:cNvPr id="29" name="Group 28"/>
            <p:cNvGrpSpPr/>
            <p:nvPr/>
          </p:nvGrpSpPr>
          <p:grpSpPr>
            <a:xfrm>
              <a:off x="1062473" y="3283971"/>
              <a:ext cx="4211923" cy="1828800"/>
              <a:chOff x="1062473" y="3283971"/>
              <a:chExt cx="4211923" cy="1828800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0675"/>
              <a:stretch/>
            </p:blipFill>
            <p:spPr>
              <a:xfrm>
                <a:off x="2650837" y="3283971"/>
                <a:ext cx="1156387" cy="182880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409" r="35744"/>
              <a:stretch/>
            </p:blipFill>
            <p:spPr>
              <a:xfrm>
                <a:off x="4194961" y="3283971"/>
                <a:ext cx="1079435" cy="1828800"/>
              </a:xfrm>
              <a:prstGeom prst="rect">
                <a:avLst/>
              </a:prstGeom>
            </p:spPr>
          </p:pic>
          <p:pic>
            <p:nvPicPr>
              <p:cNvPr id="28" name="Picture 27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0692"/>
              <a:stretch/>
            </p:blipFill>
            <p:spPr>
              <a:xfrm>
                <a:off x="1062473" y="3283971"/>
                <a:ext cx="1104349" cy="1828800"/>
              </a:xfrm>
              <a:prstGeom prst="rect">
                <a:avLst/>
              </a:prstGeom>
            </p:spPr>
          </p:pic>
        </p:grpSp>
      </p:grpSp>
      <p:sp>
        <p:nvSpPr>
          <p:cNvPr id="36" name="Title 1"/>
          <p:cNvSpPr txBox="1">
            <a:spLocks/>
          </p:cNvSpPr>
          <p:nvPr/>
        </p:nvSpPr>
        <p:spPr>
          <a:xfrm>
            <a:off x="2650837" y="357680"/>
            <a:ext cx="358177" cy="23523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itle 1"/>
          <p:cNvSpPr txBox="1">
            <a:spLocks/>
          </p:cNvSpPr>
          <p:nvPr/>
        </p:nvSpPr>
        <p:spPr>
          <a:xfrm>
            <a:off x="4138523" y="355189"/>
            <a:ext cx="358177" cy="23523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itle 1"/>
          <p:cNvSpPr txBox="1">
            <a:spLocks/>
          </p:cNvSpPr>
          <p:nvPr/>
        </p:nvSpPr>
        <p:spPr>
          <a:xfrm>
            <a:off x="1062470" y="3003281"/>
            <a:ext cx="358177" cy="23523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itle 1"/>
          <p:cNvSpPr txBox="1">
            <a:spLocks/>
          </p:cNvSpPr>
          <p:nvPr/>
        </p:nvSpPr>
        <p:spPr>
          <a:xfrm>
            <a:off x="2650836" y="3003281"/>
            <a:ext cx="358177" cy="23523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itle 1"/>
          <p:cNvSpPr txBox="1">
            <a:spLocks/>
          </p:cNvSpPr>
          <p:nvPr/>
        </p:nvSpPr>
        <p:spPr>
          <a:xfrm>
            <a:off x="4138523" y="3003281"/>
            <a:ext cx="358177" cy="23523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11371" y="5220824"/>
            <a:ext cx="841248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GB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Latha" panose="020B0604020202020204" pitchFamily="34" charset="0"/>
              </a:rPr>
              <a:t>Fig S1. DNA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Latha" panose="020B0604020202020204" pitchFamily="34" charset="0"/>
              </a:rPr>
              <a:t>fingerprinting with genomic DNA extracted from parental strain TMB3500 (first column of gel), evolved strain CC156 (middle column of gel) and biofilm (third column of gel).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Latha" panose="020B0604020202020204" pitchFamily="34" charset="0"/>
              </a:rPr>
              <a:t>Primers used include a) (GACA)</a:t>
            </a:r>
            <a:r>
              <a:rPr lang="en-GB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Latha" panose="020B0604020202020204" pitchFamily="34" charset="0"/>
              </a:rPr>
              <a:t>4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Latha" panose="020B0604020202020204" pitchFamily="34" charset="0"/>
              </a:rPr>
              <a:t> b) (GTG)</a:t>
            </a:r>
            <a:r>
              <a:rPr lang="en-GB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Latha" panose="020B0604020202020204" pitchFamily="34" charset="0"/>
              </a:rPr>
              <a:t>5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Latha" panose="020B0604020202020204" pitchFamily="34" charset="0"/>
              </a:rPr>
              <a:t> c) S1254 random primer d) TY1 primer e) TY3 primer f) TY1 + TY3 primer. One gel is displayed from each strain as a representative from triplicate analysis.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Lath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05969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91</TotalTime>
  <Words>103</Words>
  <Application>Microsoft Office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Latha</vt:lpstr>
      <vt:lpstr>Times New Roman</vt:lpstr>
      <vt:lpstr>Office Theme</vt:lpstr>
      <vt:lpstr>Adaptation to low pH and lignocellulosic inhibitors resulting in ethanolic fermentation and growth of Saccharomyces cerevisiae Venkatachalam Narayanan1, Violeta Sànchez i Nogué2, Ed WJ van Niel1* and Marie F. Gorwa-Grauslund1   1 Division of Applied Microbiology, Department of Chemistry, Lund University P.O. Box 124, SE 221 00 Lund, Sweden 2 Present address: National Bioenergy Center, National Renewable Energy Laboratory. 15013 Denver West Parkway, Golden, Colorado 80401, USA     E-mail:  venkatachalam.narayanan@tmb.lth.se violeta.sanchezinogue@nrel.gov ed.van_niel@tmb.lth.se (EvN)* marie-francoise.gorwa-grauslund@tmb.lth.se * Corresponding author </vt:lpstr>
      <vt:lpstr>A</vt:lpstr>
    </vt:vector>
  </TitlesOfParts>
  <Company>Lund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katachalam Narayanan</dc:creator>
  <cp:lastModifiedBy>Venkatachalam Narayanan</cp:lastModifiedBy>
  <cp:revision>252</cp:revision>
  <dcterms:created xsi:type="dcterms:W3CDTF">2015-07-27T12:47:00Z</dcterms:created>
  <dcterms:modified xsi:type="dcterms:W3CDTF">2016-07-14T15:00:44Z</dcterms:modified>
</cp:coreProperties>
</file>